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8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08"/>
    <p:restoredTop sz="95100"/>
  </p:normalViewPr>
  <p:slideViewPr>
    <p:cSldViewPr snapToGrid="0" snapToObjects="1">
      <p:cViewPr varScale="1">
        <p:scale>
          <a:sx n="88" d="100"/>
          <a:sy n="88" d="100"/>
        </p:scale>
        <p:origin x="94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E322EE-AD59-3848-A5FD-669DF63062A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E2B7328-49A7-D042-8A1F-C7FBBD47CC8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B05AAF-9AFA-7546-BACD-E08CEE5DD2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9FDE-4BF3-7A46-B893-4EE077C62DDA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4916EE-9651-9E49-AEF4-3EA43495D1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04E0ED-CF39-2B4A-8846-CE03C0A15F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C83A1-860F-444F-ADD2-EF1DCF246F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75706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65D084-077D-E94B-A669-6635BEA557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95290F9-60BE-C646-B852-7104194DF3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DF3217-567D-B741-A851-715B1ABD06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9FDE-4BF3-7A46-B893-4EE077C62DDA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12864D-8E80-6E4B-9B7B-48A976030E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68AA79-4CB6-584F-AA53-B5CC2220BC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C83A1-860F-444F-ADD2-EF1DCF246F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2951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532018B-58A8-504D-8136-0A1ED75CE9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DD0BEE3-5AA0-014E-969C-58812D1EA1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3CA983-FD3A-784D-A1E7-10A98AD95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9FDE-4BF3-7A46-B893-4EE077C62DDA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8446E9-D557-CE4E-92F0-99C93D7886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E8A587-BA84-9A49-8630-90DE117C15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C83A1-860F-444F-ADD2-EF1DCF246F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7405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FA00D1-11A9-4A43-BE56-9F874E6D4B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F56BC9-1D6A-FE4B-BFF5-5937EC055B3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468A2F-D3DE-7948-9E13-AEEF8E36D0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9FDE-4BF3-7A46-B893-4EE077C62DDA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1CE875-B161-8445-9ECD-D3A52513C0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65AE96-8753-B84E-BBDF-B066E30481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C83A1-860F-444F-ADD2-EF1DCF246F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18625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AE929F-F698-8F4F-A9CE-CCE35A1148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8DAED7-C7B2-4749-935D-C2DD8640E1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566CEF-4302-CC41-9C50-7E7C30475E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9FDE-4BF3-7A46-B893-4EE077C62DDA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452EA1-2C11-9048-A671-04009AE59E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52D0F2-EE8A-B944-8605-39BA81ED45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C83A1-860F-444F-ADD2-EF1DCF246F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79563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77C9C0-F4C0-CA4F-B167-8D54B4F01B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EBFCE9-0462-AB45-BEC6-AD14258D7B4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FF17BA8-A0FB-0F48-A06E-6242395032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A46AD62-A5C2-DC46-B4AD-C5DCD3B3CF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9FDE-4BF3-7A46-B893-4EE077C62DDA}" type="datetimeFigureOut">
              <a:rPr lang="en-US" smtClean="0"/>
              <a:t>12/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A018506-FD2F-ED48-8CCA-0A2E32EB9C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5EBC69-4C9B-4C41-9F5A-091A68CEA0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C83A1-860F-444F-ADD2-EF1DCF246F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20904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46882E-9E31-0F40-AD74-AEFDAE035A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29A8BB-E9EA-444F-99D5-37CBD962B9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AE88FAC-511B-8F46-8C8B-5A9A545FFC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86DE30A-CB5C-5848-921F-25E967AB870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18A5FE6-9676-2641-8806-650E67B5306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2832BEF-AF59-E047-B145-E4897DBBDE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9FDE-4BF3-7A46-B893-4EE077C62DDA}" type="datetimeFigureOut">
              <a:rPr lang="en-US" smtClean="0"/>
              <a:t>12/5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1170137-656E-B948-97C7-7635EB3D5F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596C714-443E-CD4A-8EB8-FF8EA9CEB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C83A1-860F-444F-ADD2-EF1DCF246F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9414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DB106E-5740-C34F-BCCC-5524393BBA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B9B0B51-9D81-F34D-A236-490136E9A8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9FDE-4BF3-7A46-B893-4EE077C62DDA}" type="datetimeFigureOut">
              <a:rPr lang="en-US" smtClean="0"/>
              <a:t>12/5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93B78D8-5695-BD4F-A12E-E2D37F8C9A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C9DB0D0-7C56-CF43-B25F-13DA4EC28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C83A1-860F-444F-ADD2-EF1DCF246F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2268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AF3E1CC-D00B-A844-BEA9-454E78F563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9FDE-4BF3-7A46-B893-4EE077C62DDA}" type="datetimeFigureOut">
              <a:rPr lang="en-US" smtClean="0"/>
              <a:t>12/5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555E875-6DF5-5140-9AD1-AB00CFA6F1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9D3C54D-79B2-B24F-93FF-596DCB26F9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C83A1-860F-444F-ADD2-EF1DCF246F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89506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E92228-8215-424D-8991-3DC6158DA0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8300D1-574C-C54D-B052-FA504D819F4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CC761F-79F2-6C43-A82D-CAF30560C7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86706B-DF5A-9840-856C-BB88A9B70C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9FDE-4BF3-7A46-B893-4EE077C62DDA}" type="datetimeFigureOut">
              <a:rPr lang="en-US" smtClean="0"/>
              <a:t>12/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8238ED-56DA-6348-B933-39246DE2BD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62C9AC-6B73-B843-AA97-F1584D325B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C83A1-860F-444F-ADD2-EF1DCF246F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4270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FC2502-0D35-884B-B925-D568D34153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14204EA-B238-514A-94C7-9C73987229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25B9274-C87E-394A-BF2A-DA2CFB7F38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1685B1-4B71-1C44-A196-DFA2F2ADD8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9FDE-4BF3-7A46-B893-4EE077C62DDA}" type="datetimeFigureOut">
              <a:rPr lang="en-US" smtClean="0"/>
              <a:t>12/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04D311-3042-564B-B90B-DB8478D7F1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D42CD27-953B-8E49-A7D8-DCEC6F3832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C83A1-860F-444F-ADD2-EF1DCF246F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85425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FA711DE-B835-EF42-B4E6-7EB5CEE73B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B0D3C5-BFE7-374A-B2FE-A89F00B575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51307A-9C79-DD41-8C2D-2EF0DE02478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3A9FDE-4BF3-7A46-B893-4EE077C62DDA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903D10-D0CC-7246-9685-113170EA4BB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96CCD7-8AEB-1347-B432-BC0FA8A886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8C83A1-860F-444F-ADD2-EF1DCF246F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5599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5">
            <a:extLst>
              <a:ext uri="{FF2B5EF4-FFF2-40B4-BE49-F238E27FC236}">
                <a16:creationId xmlns:a16="http://schemas.microsoft.com/office/drawing/2014/main" id="{2A4EE4A6-FF60-C541-AFF3-19AE90A44DC2}"/>
              </a:ext>
            </a:extLst>
          </p:cNvPr>
          <p:cNvSpPr txBox="1"/>
          <p:nvPr/>
        </p:nvSpPr>
        <p:spPr>
          <a:xfrm>
            <a:off x="5392374" y="260367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F9</a:t>
            </a:r>
            <a:endParaRPr lang="fr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9C5F0D7-AFDB-5642-8F4F-A41D72B8826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10083" t="-5222" r="-4566" b="-10635"/>
          <a:stretch/>
        </p:blipFill>
        <p:spPr>
          <a:xfrm>
            <a:off x="403656" y="193833"/>
            <a:ext cx="4135272" cy="2001172"/>
          </a:xfrm>
          <a:prstGeom prst="rect">
            <a:avLst/>
          </a:prstGeom>
          <a:ln>
            <a:noFill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555A837-4E97-5B47-B27E-F3537AE2A59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6576" t="-1903" r="236" b="-8501"/>
          <a:stretch/>
        </p:blipFill>
        <p:spPr>
          <a:xfrm>
            <a:off x="546921" y="2059462"/>
            <a:ext cx="3835510" cy="827242"/>
          </a:xfrm>
          <a:prstGeom prst="rect">
            <a:avLst/>
          </a:prstGeom>
          <a:ln>
            <a:noFill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9021D35-0225-124B-B31E-AE09C0F5D8B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7625" t="-10330" r="-3008" b="-11605"/>
          <a:stretch/>
        </p:blipFill>
        <p:spPr>
          <a:xfrm>
            <a:off x="469549" y="2770830"/>
            <a:ext cx="3990253" cy="913689"/>
          </a:xfrm>
          <a:prstGeom prst="rect">
            <a:avLst/>
          </a:prstGeom>
          <a:ln>
            <a:noFill/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10BD3EB-6E8C-6D4F-BF21-5EC3696FC67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-11684" t="-8999" r="-5472" b="-10309"/>
          <a:stretch/>
        </p:blipFill>
        <p:spPr>
          <a:xfrm>
            <a:off x="308643" y="3720050"/>
            <a:ext cx="4151159" cy="1484883"/>
          </a:xfrm>
          <a:prstGeom prst="rect">
            <a:avLst/>
          </a:prstGeom>
          <a:ln>
            <a:noFill/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A65CABD-325D-864D-9913-47265BCFCFF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-3001" t="-12922" r="-2938" b="-4663"/>
          <a:stretch/>
        </p:blipFill>
        <p:spPr>
          <a:xfrm>
            <a:off x="7307374" y="446654"/>
            <a:ext cx="3794076" cy="1612808"/>
          </a:xfrm>
          <a:prstGeom prst="rect">
            <a:avLst/>
          </a:prstGeom>
          <a:ln>
            <a:noFill/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69FD63F2-B26B-D045-A902-AEDC135BE5F3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-4452" t="-2723" r="-10770" b="-7865"/>
          <a:stretch/>
        </p:blipFill>
        <p:spPr>
          <a:xfrm>
            <a:off x="255011" y="5252851"/>
            <a:ext cx="3804544" cy="1502752"/>
          </a:xfrm>
          <a:prstGeom prst="rect">
            <a:avLst/>
          </a:prstGeom>
          <a:ln>
            <a:noFill/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B2902EB3-33EE-C841-914D-90F821A1C8C7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-3154" t="-9359" r="-2533" b="-4012"/>
          <a:stretch/>
        </p:blipFill>
        <p:spPr>
          <a:xfrm>
            <a:off x="7603307" y="4411807"/>
            <a:ext cx="3436101" cy="2318229"/>
          </a:xfrm>
          <a:prstGeom prst="rect">
            <a:avLst/>
          </a:prstGeom>
          <a:ln>
            <a:noFill/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673CF9FA-DE5A-6447-AE58-C9F8185A7329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-3702" t="-17748" r="-3823" b="-21151"/>
          <a:stretch/>
        </p:blipFill>
        <p:spPr>
          <a:xfrm>
            <a:off x="7307374" y="2013393"/>
            <a:ext cx="4028362" cy="1358316"/>
          </a:xfrm>
          <a:prstGeom prst="rect">
            <a:avLst/>
          </a:prstGeom>
          <a:ln>
            <a:noFill/>
          </a:ln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0568A4D6-3A2B-F44F-B603-6B23B603DB8B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-1629" t="-4198" r="-6420" b="-6653"/>
          <a:stretch/>
        </p:blipFill>
        <p:spPr>
          <a:xfrm>
            <a:off x="7420593" y="3216537"/>
            <a:ext cx="4089150" cy="1661160"/>
          </a:xfrm>
          <a:prstGeom prst="rect">
            <a:avLst/>
          </a:prstGeom>
          <a:ln>
            <a:noFill/>
          </a:ln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2A8711EC-F3B5-AA44-AF58-0694A940B9BF}"/>
              </a:ext>
            </a:extLst>
          </p:cNvPr>
          <p:cNvSpPr/>
          <p:nvPr/>
        </p:nvSpPr>
        <p:spPr>
          <a:xfrm>
            <a:off x="1004156" y="1258357"/>
            <a:ext cx="3057099" cy="45037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AEE70BB6-BA87-8941-B81B-510BA2CA0846}"/>
              </a:ext>
            </a:extLst>
          </p:cNvPr>
          <p:cNvSpPr/>
          <p:nvPr/>
        </p:nvSpPr>
        <p:spPr>
          <a:xfrm>
            <a:off x="1004155" y="619548"/>
            <a:ext cx="3057099" cy="45037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726C260-0490-EF4E-A652-909669056FFC}"/>
              </a:ext>
            </a:extLst>
          </p:cNvPr>
          <p:cNvSpPr txBox="1"/>
          <p:nvPr/>
        </p:nvSpPr>
        <p:spPr>
          <a:xfrm>
            <a:off x="4295927" y="1299337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if2</a:t>
            </a:r>
            <a:r>
              <a:rPr lang="en-US" b="1" dirty="0">
                <a:latin typeface="Symbol" pitchFamily="2" charset="2"/>
              </a:rPr>
              <a:t>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35C03DF-3599-DD42-8CD9-03EC308F3950}"/>
              </a:ext>
            </a:extLst>
          </p:cNvPr>
          <p:cNvSpPr txBox="1"/>
          <p:nvPr/>
        </p:nvSpPr>
        <p:spPr>
          <a:xfrm>
            <a:off x="4295926" y="576641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p</a:t>
            </a:r>
            <a:endParaRPr lang="en-US" b="1" dirty="0">
              <a:latin typeface="Symbol" pitchFamily="2" charset="2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E4CA3DF-65EE-904C-8024-5B1DFD1572D7}"/>
              </a:ext>
            </a:extLst>
          </p:cNvPr>
          <p:cNvSpPr txBox="1"/>
          <p:nvPr/>
        </p:nvSpPr>
        <p:spPr>
          <a:xfrm>
            <a:off x="4327842" y="2202508"/>
            <a:ext cx="7409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if2</a:t>
            </a:r>
            <a:r>
              <a:rPr lang="en-US" b="1" dirty="0">
                <a:latin typeface="Symbol" pitchFamily="2" charset="2"/>
              </a:rPr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336D5D7-4F8C-D742-9E43-FA3403E1010F}"/>
              </a:ext>
            </a:extLst>
          </p:cNvPr>
          <p:cNvSpPr txBox="1"/>
          <p:nvPr/>
        </p:nvSpPr>
        <p:spPr>
          <a:xfrm>
            <a:off x="4330846" y="3060774"/>
            <a:ext cx="7367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e1</a:t>
            </a:r>
            <a:r>
              <a:rPr lang="en-US" b="1" dirty="0">
                <a:latin typeface="Symbol" pitchFamily="2" charset="2"/>
              </a:rPr>
              <a:t>a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4FDED0F2-02E2-E242-8522-8AB9E2920A35}"/>
              </a:ext>
            </a:extLst>
          </p:cNvPr>
          <p:cNvSpPr/>
          <p:nvPr/>
        </p:nvSpPr>
        <p:spPr>
          <a:xfrm>
            <a:off x="1004155" y="4186561"/>
            <a:ext cx="3057099" cy="45037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ED8230A-1C65-E94B-9C3E-4FA54B15E828}"/>
              </a:ext>
            </a:extLst>
          </p:cNvPr>
          <p:cNvSpPr txBox="1"/>
          <p:nvPr/>
        </p:nvSpPr>
        <p:spPr>
          <a:xfrm>
            <a:off x="4261974" y="4284019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p1s</a:t>
            </a:r>
            <a:endParaRPr lang="en-US" b="1" dirty="0">
              <a:latin typeface="Symbol" pitchFamily="2" charset="2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70D33939-EF9F-1742-9BEF-20B13C5A21A5}"/>
              </a:ext>
            </a:extLst>
          </p:cNvPr>
          <p:cNvSpPr/>
          <p:nvPr/>
        </p:nvSpPr>
        <p:spPr>
          <a:xfrm>
            <a:off x="7792809" y="887609"/>
            <a:ext cx="3057099" cy="45037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ADDDECB-EAA1-7243-AF10-B90C2B99FB03}"/>
              </a:ext>
            </a:extLst>
          </p:cNvPr>
          <p:cNvSpPr txBox="1"/>
          <p:nvPr/>
        </p:nvSpPr>
        <p:spPr>
          <a:xfrm>
            <a:off x="11008696" y="887609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op</a:t>
            </a:r>
            <a:endParaRPr lang="en-US" b="1" dirty="0">
              <a:latin typeface="Symbol" pitchFamily="2" charset="2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0F6C898-9A52-D34C-91A8-48FF941033B0}"/>
              </a:ext>
            </a:extLst>
          </p:cNvPr>
          <p:cNvSpPr txBox="1"/>
          <p:nvPr/>
        </p:nvSpPr>
        <p:spPr>
          <a:xfrm>
            <a:off x="11192622" y="2342785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4Ebp1</a:t>
            </a:r>
            <a:endParaRPr lang="en-US" b="1" dirty="0">
              <a:latin typeface="Symbol" pitchFamily="2" charset="2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6B6577A-6DC6-7243-B9FE-1D0F953B3D4E}"/>
              </a:ext>
            </a:extLst>
          </p:cNvPr>
          <p:cNvSpPr txBox="1"/>
          <p:nvPr/>
        </p:nvSpPr>
        <p:spPr>
          <a:xfrm>
            <a:off x="11203616" y="3637638"/>
            <a:ext cx="825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Ebp1</a:t>
            </a:r>
            <a:endParaRPr lang="en-US" b="1" dirty="0">
              <a:latin typeface="Symbol" pitchFamily="2" charset="2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6B535A1-663C-7140-87A2-EA00D7F4704D}"/>
              </a:ext>
            </a:extLst>
          </p:cNvPr>
          <p:cNvSpPr txBox="1"/>
          <p:nvPr/>
        </p:nvSpPr>
        <p:spPr>
          <a:xfrm>
            <a:off x="11008696" y="5896175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rd7</a:t>
            </a:r>
            <a:endParaRPr lang="en-US" b="1" dirty="0">
              <a:latin typeface="Symbol" pitchFamily="2" charset="2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CB9DE45-0484-D243-A226-712C7A23394A}"/>
              </a:ext>
            </a:extLst>
          </p:cNvPr>
          <p:cNvSpPr txBox="1"/>
          <p:nvPr/>
        </p:nvSpPr>
        <p:spPr>
          <a:xfrm>
            <a:off x="3640209" y="5739302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90</a:t>
            </a:r>
            <a:endParaRPr lang="en-US" b="1" dirty="0">
              <a:latin typeface="Symbol" pitchFamily="2" charset="2"/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CF7EF764-479A-7E4D-A8E1-99754F21CA50}"/>
              </a:ext>
            </a:extLst>
          </p:cNvPr>
          <p:cNvSpPr/>
          <p:nvPr/>
        </p:nvSpPr>
        <p:spPr>
          <a:xfrm>
            <a:off x="7792809" y="2333972"/>
            <a:ext cx="3057099" cy="45037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253E3EF1-E95B-FD46-A3E5-2AA829448AB3}"/>
              </a:ext>
            </a:extLst>
          </p:cNvPr>
          <p:cNvSpPr/>
          <p:nvPr/>
        </p:nvSpPr>
        <p:spPr>
          <a:xfrm>
            <a:off x="7696448" y="5815131"/>
            <a:ext cx="3057099" cy="45037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F4590335-F26E-F544-968D-1CEC09562D30}"/>
              </a:ext>
            </a:extLst>
          </p:cNvPr>
          <p:cNvSpPr/>
          <p:nvPr/>
        </p:nvSpPr>
        <p:spPr>
          <a:xfrm>
            <a:off x="491753" y="5653598"/>
            <a:ext cx="3057099" cy="45037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B183D66-A45D-734B-9ABC-03DCB6C3FC17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5650599" y="4013166"/>
            <a:ext cx="558800" cy="3022600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96852460-0CEC-F34C-A081-4F2B2FD98DF9}"/>
              </a:ext>
            </a:extLst>
          </p:cNvPr>
          <p:cNvSpPr txBox="1"/>
          <p:nvPr/>
        </p:nvSpPr>
        <p:spPr>
          <a:xfrm>
            <a:off x="4538928" y="5815131"/>
            <a:ext cx="25536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90 (second membrane, not shown in Expanded View Figure 9)</a:t>
            </a:r>
          </a:p>
        </p:txBody>
      </p:sp>
    </p:spTree>
    <p:extLst>
      <p:ext uri="{BB962C8B-B14F-4D97-AF65-F5344CB8AC3E}">
        <p14:creationId xmlns:p14="http://schemas.microsoft.com/office/powerpoint/2010/main" val="42608562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</Words>
  <Application>Microsoft Macintosh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icrosoft Office User</dc:creator>
  <cp:keywords/>
  <dc:description/>
  <cp:lastModifiedBy>Microsoft Office User</cp:lastModifiedBy>
  <cp:revision>1</cp:revision>
  <dcterms:created xsi:type="dcterms:W3CDTF">2025-12-05T15:10:03Z</dcterms:created>
  <dcterms:modified xsi:type="dcterms:W3CDTF">2025-12-05T15:10:21Z</dcterms:modified>
  <cp:category/>
</cp:coreProperties>
</file>